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9C2092-D633-4005-BD06-4EC9A6ED7B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D99E3F-7686-441B-8C30-0B4CCB9BDF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DCD94E-6E95-4BBD-83F5-FC8B42C07F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8A3A6D-E945-4FE4-9424-FBDF0081BB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58800-AAFB-43A2-A488-1B8453E06D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F8A28-4C04-4045-8560-48EF5F8472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7DAE0B-35FE-486D-913C-593678F4A9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7B7F5-8786-49D4-B6F9-D737AE4D19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AAB4AD-B7EB-4B3D-AF9B-9D88AE8D38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AA531E-5FD5-463D-95BA-DAEDA7D352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036A59-F305-41D6-B0CE-F4085E2C1B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E2E770-DE53-4E89-ABEE-EEB69CAF0E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1BF61E-E9F2-459B-9FA3-0EB77E18689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68360" y="333360"/>
            <a:ext cx="7920000" cy="575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Additional file 5 Gene Ontology (GO) enrichment analysis of 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fferentially expressed gene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 at three HS-treatment time point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Vertical axis displays the percentage of significant genes corresponding to each functional type. Horizontal axis displays the GO annotation corresponding to the three categories: from left to right: BP, CC and MF, represented by colors: blue, green and red), respectively. BP=Biological Process; CC=Cellular Compartment; MF=Molecular Functio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. (A) (B) (C) represents th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tegorie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 of the three time points (HS_0.5h, HS_2h, HS_1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h) </a:t>
            </a:r>
            <a:r>
              <a:rPr b="0" lang="en-US" sz="1200" spc="-1" strike="noStrike" u="sng">
                <a:solidFill>
                  <a:srgbClr val="009999"/>
                </a:solidFill>
                <a:uFillTx/>
                <a:latin typeface="Times New Roman"/>
              </a:rPr>
              <a:t>compar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d with control samples (HS_0), </a:t>
            </a:r>
            <a:r>
              <a:rPr b="0" lang="en-US" sz="1200" spc="-1" strike="noStrike" u="sng">
                <a:solidFill>
                  <a:srgbClr val="009999"/>
                </a:solidFill>
                <a:uFillTx/>
                <a:latin typeface="Times New Roman"/>
              </a:rPr>
              <a:t>respectively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04920" y="1643040"/>
            <a:ext cx="66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1332000" y="1809720"/>
            <a:ext cx="6480000" cy="3238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/>
          </p:nvPr>
        </p:nvSpPr>
        <p:spPr>
          <a:xfrm>
            <a:off x="457200" y="404640"/>
            <a:ext cx="8229600" cy="572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10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1332000" y="1809720"/>
            <a:ext cx="6480000" cy="3238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/>
          </p:nvPr>
        </p:nvSpPr>
        <p:spPr>
          <a:xfrm>
            <a:off x="457200" y="404640"/>
            <a:ext cx="8229600" cy="572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10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10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1332000" y="1809720"/>
            <a:ext cx="6480000" cy="3238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5T08:13:59Z</dcterms:created>
  <dc:creator>xueli</dc:creator>
  <dc:description/>
  <dc:language>en-US</dc:language>
  <cp:lastModifiedBy/>
  <dcterms:modified xsi:type="dcterms:W3CDTF">2015-05-12T11:33:04Z</dcterms:modified>
  <cp:revision>0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KSOProductBuildVer">
    <vt:lpwstr>2052-9.1.0.4993</vt:lpwstr>
  </property>
  <property fmtid="{D5CDD505-2E9C-101B-9397-08002B2CF9AE}" pid="6" name="TitleName">
    <vt:lpwstr>Presentation 1.PPT</vt:lpwstr>
  </property>
</Properties>
</file>